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BA724E3-EA86-46AE-A405-9724D3C64D34}" v="1" dt="2024-09-24T15:38:13.89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53" y="1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7BA724E3-EA86-46AE-A405-9724D3C64D34}"/>
    <pc:docChg chg="modSld">
      <pc:chgData name="Laycock, Joseph" userId="c4bfcbf4-3ccc-440e-b317-559baf184f0d" providerId="ADAL" clId="{7BA724E3-EA86-46AE-A405-9724D3C64D34}" dt="2024-09-24T15:38:17.562" v="4" actId="20577"/>
      <pc:docMkLst>
        <pc:docMk/>
      </pc:docMkLst>
      <pc:sldChg chg="modSp mod">
        <pc:chgData name="Laycock, Joseph" userId="c4bfcbf4-3ccc-440e-b317-559baf184f0d" providerId="ADAL" clId="{7BA724E3-EA86-46AE-A405-9724D3C64D34}" dt="2024-09-24T15:38:17.562" v="4" actId="20577"/>
        <pc:sldMkLst>
          <pc:docMk/>
          <pc:sldMk cId="1305034209" sldId="274"/>
        </pc:sldMkLst>
        <pc:spChg chg="mod">
          <ac:chgData name="Laycock, Joseph" userId="c4bfcbf4-3ccc-440e-b317-559baf184f0d" providerId="ADAL" clId="{7BA724E3-EA86-46AE-A405-9724D3C64D34}" dt="2024-09-24T15:38:17.562" v="4" actId="20577"/>
          <ac:spMkLst>
            <pc:docMk/>
            <pc:sldMk cId="1305034209" sldId="274"/>
            <ac:spMk id="6" creationId="{227EDAF1-7831-6434-E4A2-E1969092C1E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09FF57FC-A17C-A160-09AA-43C39028D9CB}"/>
              </a:ext>
            </a:extLst>
          </p:cNvPr>
          <p:cNvSpPr/>
          <p:nvPr/>
        </p:nvSpPr>
        <p:spPr>
          <a:xfrm>
            <a:off x="4499552" y="238921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nborn errors of metabolism in </a:t>
            </a:r>
            <a:r>
              <a:rPr lang="en-US" sz="2800" b="1">
                <a:solidFill>
                  <a:schemeClr val="bg1"/>
                </a:solidFill>
              </a:rPr>
              <a:t>neonates and </a:t>
            </a:r>
            <a:r>
              <a:rPr lang="en-US" sz="2800" b="1" dirty="0">
                <a:solidFill>
                  <a:schemeClr val="bg1"/>
                </a:solidFill>
              </a:rPr>
              <a:t>pediatrics on varying dialysis modalities: a systematic review and meta-analysi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180182" y="1189759"/>
            <a:ext cx="11822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Evaluate mortality and efficiency of different kidney replacement therapy modalities in children with IEM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aina, Doshi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CKRT trends toward lower mortality, while HD shows faster ammonia reduction. Further validation of KRT modalities in neonates with IEMs is needed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F699EA1-29EA-A25F-8D20-B1294B1013EA}"/>
              </a:ext>
            </a:extLst>
          </p:cNvPr>
          <p:cNvSpPr/>
          <p:nvPr/>
        </p:nvSpPr>
        <p:spPr>
          <a:xfrm>
            <a:off x="5223698" y="1871204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37 total studie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CFF136C-88FA-FB3E-14EE-9FFC02F258AC}"/>
              </a:ext>
            </a:extLst>
          </p:cNvPr>
          <p:cNvSpPr/>
          <p:nvPr/>
        </p:nvSpPr>
        <p:spPr>
          <a:xfrm>
            <a:off x="5223698" y="2854293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642 patient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16B1E88-B992-DAA2-8D88-986DEBB2418B}"/>
              </a:ext>
            </a:extLst>
          </p:cNvPr>
          <p:cNvSpPr/>
          <p:nvPr/>
        </p:nvSpPr>
        <p:spPr>
          <a:xfrm>
            <a:off x="5223698" y="3837382"/>
            <a:ext cx="1728385" cy="1670089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Some studies include multiple modalities:</a:t>
            </a:r>
          </a:p>
          <a:p>
            <a:pPr algn="ctr"/>
            <a:r>
              <a:rPr lang="en-GB" dirty="0"/>
              <a:t>28 CKRT studies</a:t>
            </a:r>
          </a:p>
          <a:p>
            <a:pPr algn="ctr"/>
            <a:r>
              <a:rPr lang="en-GB" dirty="0"/>
              <a:t>13 PD studies</a:t>
            </a:r>
            <a:br>
              <a:rPr lang="en-GB" dirty="0"/>
            </a:br>
            <a:r>
              <a:rPr lang="en-GB" dirty="0"/>
              <a:t>7 HD studies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48E5FFB0-26C8-A92F-7F2B-EA5DC555BC2A}"/>
              </a:ext>
            </a:extLst>
          </p:cNvPr>
          <p:cNvCxnSpPr>
            <a:cxnSpLocks/>
          </p:cNvCxnSpPr>
          <p:nvPr/>
        </p:nvCxnSpPr>
        <p:spPr>
          <a:xfrm>
            <a:off x="3158511" y="3479193"/>
            <a:ext cx="668239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>
            <a:extLst>
              <a:ext uri="{FF2B5EF4-FFF2-40B4-BE49-F238E27FC236}">
                <a16:creationId xmlns:a16="http://schemas.microsoft.com/office/drawing/2014/main" id="{B2E8B5AF-A7B7-EBC9-9296-78D2CDC94482}"/>
              </a:ext>
            </a:extLst>
          </p:cNvPr>
          <p:cNvSpPr/>
          <p:nvPr/>
        </p:nvSpPr>
        <p:spPr>
          <a:xfrm>
            <a:off x="173448" y="2185303"/>
            <a:ext cx="2842053" cy="1960820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PubMed, Web of Science, and Embase</a:t>
            </a:r>
          </a:p>
          <a:p>
            <a:pPr algn="ctr"/>
            <a:r>
              <a:rPr lang="en-US" dirty="0"/>
              <a:t>Included: survival rates reported in patients with IEM with an intervention of CKRT, PD, or HD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CB6F65A-58BD-7159-376F-1C131C01E888}"/>
              </a:ext>
            </a:extLst>
          </p:cNvPr>
          <p:cNvSpPr/>
          <p:nvPr/>
        </p:nvSpPr>
        <p:spPr>
          <a:xfrm>
            <a:off x="180182" y="4309806"/>
            <a:ext cx="2835319" cy="80589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Excluded: </a:t>
            </a:r>
            <a:r>
              <a:rPr lang="en-US" dirty="0">
                <a:solidFill>
                  <a:srgbClr val="AA0065"/>
                </a:solidFill>
              </a:rPr>
              <a:t>Patients receiving unclear or multiple KRT modalities </a:t>
            </a:r>
            <a:r>
              <a:rPr lang="en-GB" dirty="0">
                <a:solidFill>
                  <a:srgbClr val="AA0065"/>
                </a:solidFill>
              </a:rPr>
              <a:t> </a:t>
            </a:r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4A6CDF56-69F7-FBDA-84D6-51AF2A2851D4}"/>
              </a:ext>
            </a:extLst>
          </p:cNvPr>
          <p:cNvSpPr/>
          <p:nvPr/>
        </p:nvSpPr>
        <p:spPr>
          <a:xfrm>
            <a:off x="4115131" y="290405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814EB652-68A1-F563-9B94-197EB2660A4F}"/>
              </a:ext>
            </a:extLst>
          </p:cNvPr>
          <p:cNvSpPr/>
          <p:nvPr/>
        </p:nvSpPr>
        <p:spPr>
          <a:xfrm>
            <a:off x="3760891" y="350055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8658368-A681-862C-162A-C5C585AC7F6B}"/>
              </a:ext>
            </a:extLst>
          </p:cNvPr>
          <p:cNvSpPr/>
          <p:nvPr/>
        </p:nvSpPr>
        <p:spPr>
          <a:xfrm>
            <a:off x="8484974" y="1913398"/>
            <a:ext cx="3385750" cy="3408245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65AA00"/>
                </a:solidFill>
              </a:rPr>
              <a:t>50% reduction of ammonia level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65AA00"/>
                </a:solidFill>
              </a:rPr>
              <a:t>CKRT: 6.5 hou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65AA00"/>
                </a:solidFill>
              </a:rPr>
              <a:t>PD: 14.4 hou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65AA00"/>
                </a:solidFill>
              </a:rPr>
              <a:t>HD: 1.6 hours</a:t>
            </a:r>
          </a:p>
          <a:p>
            <a:r>
              <a:rPr lang="en-US" dirty="0">
                <a:solidFill>
                  <a:srgbClr val="65AA00"/>
                </a:solidFill>
              </a:rPr>
              <a:t>Mortality: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65AA00"/>
                </a:solidFill>
              </a:rPr>
              <a:t>CKRT: 24.84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65AA00"/>
                </a:solidFill>
              </a:rPr>
              <a:t>PD: 34.42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65AA00"/>
                </a:solidFill>
              </a:rPr>
              <a:t>HD: 34.14%</a:t>
            </a:r>
          </a:p>
          <a:p>
            <a:r>
              <a:rPr lang="en-GB" dirty="0">
                <a:solidFill>
                  <a:srgbClr val="65AA00"/>
                </a:solidFill>
              </a:rPr>
              <a:t>However, between group comparisons not tested</a:t>
            </a:r>
            <a:endParaRPr lang="en-US" dirty="0">
              <a:solidFill>
                <a:srgbClr val="65AA00"/>
              </a:solidFill>
            </a:endParaRPr>
          </a:p>
          <a:p>
            <a:pPr lvl="1"/>
            <a:endParaRPr lang="en-US" dirty="0">
              <a:solidFill>
                <a:srgbClr val="65AA00"/>
              </a:solidFill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8C772D23-5E7E-ED58-9CBA-E4A8AD9A77EC}"/>
              </a:ext>
            </a:extLst>
          </p:cNvPr>
          <p:cNvCxnSpPr/>
          <p:nvPr/>
        </p:nvCxnSpPr>
        <p:spPr>
          <a:xfrm>
            <a:off x="7449291" y="3500550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0503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76</TotalTime>
  <Words>165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2</cp:revision>
  <dcterms:created xsi:type="dcterms:W3CDTF">2019-06-13T12:30:18Z</dcterms:created>
  <dcterms:modified xsi:type="dcterms:W3CDTF">2024-09-24T15:38:25Z</dcterms:modified>
</cp:coreProperties>
</file>